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handoutMasterIdLst>
    <p:handoutMasterId r:id="rId5"/>
  </p:handoutMasterIdLst>
  <p:sldIdLst>
    <p:sldId id="265" r:id="rId2"/>
    <p:sldId id="271" r:id="rId3"/>
  </p:sldIdLst>
  <p:sldSz cx="9144000" cy="6858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  <p:ext uri="{2D200454-40CA-4A62-9FC3-DE9A4176ACB9}">
      <p15:notes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reeman, Zachary" initials="FZ" lastIdx="6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  <a:srgbClr val="00FF00"/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513" autoAdjust="0"/>
    <p:restoredTop sz="69903" autoAdjust="0"/>
  </p:normalViewPr>
  <p:slideViewPr>
    <p:cSldViewPr snapToGrid="0">
      <p:cViewPr>
        <p:scale>
          <a:sx n="160" d="100"/>
          <a:sy n="160" d="100"/>
        </p:scale>
        <p:origin x="-252" y="34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73" d="100"/>
          <a:sy n="73" d="100"/>
        </p:scale>
        <p:origin x="2262" y="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handoutMaster" Target="handoutMasters/handoutMaster1.xml"/><Relationship Id="rId10" Type="http://schemas.openxmlformats.org/officeDocument/2006/relationships/tableStyles" Target="tableStyles.xml"/><Relationship Id="rId4" Type="http://schemas.openxmlformats.org/officeDocument/2006/relationships/notesMaster" Target="notesMasters/notesMaster1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41968" cy="467451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6740" y="1"/>
            <a:ext cx="3041968" cy="467451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r">
              <a:defRPr sz="1200"/>
            </a:lvl1pPr>
          </a:lstStyle>
          <a:p>
            <a:fld id="{DBD3558C-0035-48B5-AB58-788A86F55A4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38476"/>
            <a:ext cx="3041968" cy="467450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6740" y="8838476"/>
            <a:ext cx="3041968" cy="467450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r">
              <a:defRPr sz="1200"/>
            </a:lvl1pPr>
          </a:lstStyle>
          <a:p>
            <a:fld id="{B777CC2A-ED66-41CA-8D7C-0DED167903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32909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41968" cy="466912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4" y="1"/>
            <a:ext cx="3041968" cy="466912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r">
              <a:defRPr sz="1200"/>
            </a:lvl1pPr>
          </a:lstStyle>
          <a:p>
            <a:fld id="{58E5CAB3-8DA8-4612-9FB4-C043D70D76FF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6050" y="1163638"/>
            <a:ext cx="4187825" cy="3140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79" tIns="46641" rIns="93279" bIns="4664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78477"/>
            <a:ext cx="5615940" cy="3664209"/>
          </a:xfrm>
          <a:prstGeom prst="rect">
            <a:avLst/>
          </a:prstGeom>
        </p:spPr>
        <p:txBody>
          <a:bodyPr vert="horz" lIns="93279" tIns="46641" rIns="93279" bIns="46641" rtlCol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5"/>
            <a:ext cx="3041968" cy="466911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4" y="8839015"/>
            <a:ext cx="3041968" cy="466911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r">
              <a:defRPr sz="1200"/>
            </a:lvl1pPr>
          </a:lstStyle>
          <a:p>
            <a:fld id="{B9F49ED3-0D8E-400C-AB96-46AED9631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864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16050" y="1163638"/>
            <a:ext cx="4187825" cy="31400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ifferentially expressed genes between DU145 cells treated as indicated. 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F49ED3-0D8E-400C-AB96-46AED96312B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0350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16050" y="1163638"/>
            <a:ext cx="4187825" cy="31400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op 20 upregulated and downregulated genes between the 1uM JQ1 + IFN</a:t>
            </a:r>
            <a:r>
              <a:rPr lang="el-G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γ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s IFN</a:t>
            </a:r>
            <a:r>
              <a:rPr lang="el-G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γ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eated groups in PC3 cells. 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&lt;0.05 for all significantly differentially expressed genes. N=3/group, repeated x 1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F49ED3-0D8E-400C-AB96-46AED96312B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22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567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114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0970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953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401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292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851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3503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831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102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560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589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62" y="1960341"/>
            <a:ext cx="2470039" cy="327523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44555" y="2243564"/>
            <a:ext cx="2269679" cy="300956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15131" y="2174659"/>
            <a:ext cx="2328869" cy="3088044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628066" y="1774333"/>
            <a:ext cx="1252266" cy="30008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350" dirty="0">
                <a:latin typeface="ArialMT"/>
              </a:rPr>
              <a:t>DMSO  v JQ1</a:t>
            </a:r>
            <a:endParaRPr lang="en-US" sz="1350" dirty="0"/>
          </a:p>
        </p:txBody>
      </p:sp>
      <p:sp>
        <p:nvSpPr>
          <p:cNvPr id="9" name="Rectangle 8"/>
          <p:cNvSpPr/>
          <p:nvPr/>
        </p:nvSpPr>
        <p:spPr>
          <a:xfrm>
            <a:off x="3329110" y="1774333"/>
            <a:ext cx="1300356" cy="30008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350" dirty="0">
                <a:latin typeface="ArialMT"/>
              </a:rPr>
              <a:t>DMSO v IFN</a:t>
            </a:r>
            <a:r>
              <a:rPr lang="el-GR" sz="1350" dirty="0">
                <a:latin typeface="ArialMT"/>
              </a:rPr>
              <a:t>γ </a:t>
            </a:r>
            <a:endParaRPr lang="en-US" sz="1350" dirty="0"/>
          </a:p>
        </p:txBody>
      </p:sp>
      <p:sp>
        <p:nvSpPr>
          <p:cNvPr id="10" name="Rectangle 9"/>
          <p:cNvSpPr/>
          <p:nvPr/>
        </p:nvSpPr>
        <p:spPr>
          <a:xfrm>
            <a:off x="5528093" y="1774333"/>
            <a:ext cx="1146468" cy="30008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350" dirty="0">
                <a:latin typeface="ArialMT"/>
              </a:rPr>
              <a:t>JQ1 v  IFN</a:t>
            </a:r>
            <a:r>
              <a:rPr lang="el-GR" sz="1350" dirty="0">
                <a:latin typeface="ArialMT"/>
              </a:rPr>
              <a:t>γ </a:t>
            </a:r>
            <a:endParaRPr lang="en-US" sz="1350" dirty="0"/>
          </a:p>
        </p:txBody>
      </p:sp>
      <p:sp>
        <p:nvSpPr>
          <p:cNvPr id="11" name="Rectangle 10"/>
          <p:cNvSpPr/>
          <p:nvPr/>
        </p:nvSpPr>
        <p:spPr>
          <a:xfrm>
            <a:off x="7161756" y="1774333"/>
            <a:ext cx="1791222" cy="30008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350" dirty="0">
                <a:latin typeface="ArialMT"/>
              </a:rPr>
              <a:t>IFN</a:t>
            </a:r>
            <a:r>
              <a:rPr lang="el-GR" sz="1350" dirty="0">
                <a:latin typeface="ArialMT"/>
              </a:rPr>
              <a:t>γ </a:t>
            </a:r>
            <a:r>
              <a:rPr lang="en-US" sz="1350" dirty="0">
                <a:latin typeface="ArialMT"/>
              </a:rPr>
              <a:t> v JQ1 +IFN</a:t>
            </a:r>
            <a:r>
              <a:rPr lang="el-GR" sz="1350" dirty="0">
                <a:latin typeface="ArialMT"/>
              </a:rPr>
              <a:t>γ </a:t>
            </a:r>
            <a:endParaRPr lang="en-US" sz="135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1071" y="2243564"/>
            <a:ext cx="2688204" cy="2950233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>
            <a:off x="231464" y="1265830"/>
            <a:ext cx="793204" cy="30008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35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-25478" y="6573731"/>
            <a:ext cx="39794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ao et. al. </a:t>
            </a:r>
          </a:p>
        </p:txBody>
      </p:sp>
    </p:spTree>
    <p:extLst>
      <p:ext uri="{BB962C8B-B14F-4D97-AF65-F5344CB8AC3E}">
        <p14:creationId xmlns:p14="http://schemas.microsoft.com/office/powerpoint/2010/main" val="3245041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876" t="5062" r="2808" b="26477"/>
          <a:stretch/>
        </p:blipFill>
        <p:spPr>
          <a:xfrm>
            <a:off x="1881442" y="969052"/>
            <a:ext cx="6744769" cy="422423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55341" y="1050266"/>
            <a:ext cx="826101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C13orf16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MUC13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BATF2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SCG5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BST2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C1S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C1R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ANXA10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IL32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AIM2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HLA-DPA1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IFITM1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CXCL9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S100A2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KRT81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GBP5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CXCL11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HLA-DRA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HLA-DRB1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IL13RA2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PNMA1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TUBB3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HIST1H4H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CNFN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C9orf16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LOC100507025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G6PD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IZUMO4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CCDC85B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DUSP6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GDF11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NR2F1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RGS2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HIST2H2BE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TM7SF2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HIST1H3H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HCFC1R1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MT2A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MT1X</a:t>
            </a:r>
          </a:p>
          <a:p>
            <a:pPr algn="r"/>
            <a:r>
              <a:rPr lang="en-US" sz="675" b="1" dirty="0">
                <a:latin typeface="Arial" panose="020B0604020202020204" pitchFamily="34" charset="0"/>
                <a:cs typeface="Arial" panose="020B0604020202020204" pitchFamily="34" charset="0"/>
              </a:rPr>
              <a:t>CTGF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2239304" y="5274500"/>
            <a:ext cx="6210645" cy="461665"/>
            <a:chOff x="8126364" y="5741648"/>
            <a:chExt cx="8115926" cy="711958"/>
          </a:xfrm>
        </p:grpSpPr>
        <p:sp>
          <p:nvSpPr>
            <p:cNvPr id="7" name="TextBox 6"/>
            <p:cNvSpPr txBox="1"/>
            <p:nvPr/>
          </p:nvSpPr>
          <p:spPr>
            <a:xfrm>
              <a:off x="9496664" y="5741648"/>
              <a:ext cx="1659947" cy="4271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.1 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 JQ1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4582343" y="5741648"/>
              <a:ext cx="1659947" cy="4271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0 u/mL IFN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2585869" y="5741648"/>
              <a:ext cx="1909330" cy="7119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 JQ1 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+ IFN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0925921" y="5741648"/>
              <a:ext cx="1909330" cy="7119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.1 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 JQ1 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+ IFN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8126364" y="5741648"/>
              <a:ext cx="2200275" cy="4271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</p:grp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71" t="86198" r="25174" b="5731"/>
          <a:stretch/>
        </p:blipFill>
        <p:spPr>
          <a:xfrm rot="16200000">
            <a:off x="7669700" y="2788320"/>
            <a:ext cx="2246899" cy="333877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8793149" y="1908882"/>
            <a:ext cx="261686" cy="219290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  <a:p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cxnSp>
        <p:nvCxnSpPr>
          <p:cNvPr id="14" name="Straight Connector 13"/>
          <p:cNvCxnSpPr/>
          <p:nvPr/>
        </p:nvCxnSpPr>
        <p:spPr>
          <a:xfrm rot="10800000">
            <a:off x="1897793" y="5264277"/>
            <a:ext cx="0" cy="34737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 rot="16200000">
            <a:off x="1392789" y="5248057"/>
            <a:ext cx="67613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Arial" panose="020B0604020202020204" pitchFamily="34" charset="0"/>
                <a:cs typeface="Arial" panose="020B0604020202020204" pitchFamily="34" charset="0"/>
              </a:rPr>
              <a:t>PC3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85528" y="1050265"/>
            <a:ext cx="46981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-25478" y="6573731"/>
            <a:ext cx="39794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ao et. al. </a:t>
            </a:r>
          </a:p>
        </p:txBody>
      </p:sp>
    </p:spTree>
    <p:extLst>
      <p:ext uri="{BB962C8B-B14F-4D97-AF65-F5344CB8AC3E}">
        <p14:creationId xmlns:p14="http://schemas.microsoft.com/office/powerpoint/2010/main" val="5986358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15</TotalTime>
  <Words>155</Words>
  <Application>Microsoft Office PowerPoint</Application>
  <PresentationFormat>On-screen Show (4:3)</PresentationFormat>
  <Paragraphs>74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Columbia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per Figures</dc:title>
  <dc:creator>Mao, Wendy</dc:creator>
  <cp:lastModifiedBy>USER</cp:lastModifiedBy>
  <cp:revision>253</cp:revision>
  <cp:lastPrinted>2019-02-04T21:11:13Z</cp:lastPrinted>
  <dcterms:created xsi:type="dcterms:W3CDTF">2018-06-19T14:49:33Z</dcterms:created>
  <dcterms:modified xsi:type="dcterms:W3CDTF">2019-10-08T02:55:34Z</dcterms:modified>
</cp:coreProperties>
</file>